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564" y="-4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2FE3A4-5BEB-4F47-AFBC-2EFAF9797F86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49C7EE-81F3-4FCF-BCA4-7B48BEE6564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31965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49C7EE-81F3-4FCF-BCA4-7B48BEE6564A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199776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16443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65052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6298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31479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15149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89130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76905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5380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74029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540366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6187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E5BDB-8881-4C21-A60E-8ABC55A5EFD8}" type="datetimeFigureOut">
              <a:rPr kumimoji="1" lang="ja-JP" altLang="en-US" smtClean="0"/>
              <a:pPr/>
              <a:t>2013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FB06D-F48D-48E3-84E5-39FFD372EE8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91490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3264501" y="3041905"/>
            <a:ext cx="288032" cy="13493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/>
          <p:cNvSpPr/>
          <p:nvPr/>
        </p:nvSpPr>
        <p:spPr>
          <a:xfrm>
            <a:off x="2400405" y="4149080"/>
            <a:ext cx="288032" cy="23747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" name="直線コネクタ 7"/>
          <p:cNvCxnSpPr/>
          <p:nvPr/>
        </p:nvCxnSpPr>
        <p:spPr>
          <a:xfrm>
            <a:off x="1253215" y="4411831"/>
            <a:ext cx="25922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1245840" y="2303703"/>
            <a:ext cx="7375" cy="2109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1150143" y="2317462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1156967" y="2993817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1163791" y="3693425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1170615" y="4403979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754221" y="214069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smtClean="0">
                <a:latin typeface="Arial" pitchFamily="34" charset="0"/>
                <a:cs typeface="Arial" pitchFamily="34" charset="0"/>
              </a:rPr>
              <a:t>0.6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54221" y="2838874"/>
            <a:ext cx="470000" cy="409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4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54221" y="3522494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2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911315" y="420789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直線コネクタ 26"/>
          <p:cNvCxnSpPr/>
          <p:nvPr/>
        </p:nvCxnSpPr>
        <p:spPr>
          <a:xfrm>
            <a:off x="3408517" y="2384428"/>
            <a:ext cx="0" cy="864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>
            <a:off x="3365526" y="2389824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2560088" y="4063423"/>
            <a:ext cx="0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2511471" y="4046641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 rot="16200000">
            <a:off x="-339668" y="3149497"/>
            <a:ext cx="1685077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600"/>
              </a:lnSpc>
            </a:pPr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kumimoji="1" lang="en-US" altLang="ja-JP" sz="1600" b="1" dirty="0" smtClean="0">
                <a:latin typeface="Symbol" pitchFamily="18" charset="2"/>
                <a:cs typeface="Arial" pitchFamily="34" charset="0"/>
              </a:rPr>
              <a:t>b</a:t>
            </a:r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40</a:t>
            </a:r>
          </a:p>
          <a:p>
            <a:pPr algn="ctr">
              <a:lnSpc>
                <a:spcPts val="1600"/>
              </a:lnSpc>
            </a:pP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600" b="1" dirty="0">
                <a:latin typeface="Symbol" pitchFamily="18" charset="2"/>
                <a:cs typeface="Arial" pitchFamily="34" charset="0"/>
              </a:rPr>
              <a:t>m</a:t>
            </a: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g/mg protein)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線コネクタ 38"/>
          <p:cNvCxnSpPr/>
          <p:nvPr/>
        </p:nvCxnSpPr>
        <p:spPr>
          <a:xfrm>
            <a:off x="3413374" y="4392561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2542535" y="4392400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1782668" y="4398445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1633326" y="4396833"/>
            <a:ext cx="2880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1440954" y="207913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619672" y="457722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4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2310276" y="457722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itchFamily="34" charset="0"/>
                <a:cs typeface="Arial" pitchFamily="34" charset="0"/>
              </a:rPr>
              <a:t>10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198493" y="457722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itchFamily="34" charset="0"/>
                <a:cs typeface="Arial" pitchFamily="34" charset="0"/>
              </a:rPr>
              <a:t>15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723961" y="4869160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Age (months)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7446320" y="3861048"/>
            <a:ext cx="288032" cy="131443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0" name="直線コネクタ 59"/>
          <p:cNvCxnSpPr/>
          <p:nvPr/>
        </p:nvCxnSpPr>
        <p:spPr>
          <a:xfrm>
            <a:off x="5465572" y="5196081"/>
            <a:ext cx="25922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5458197" y="3087953"/>
            <a:ext cx="7375" cy="2109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5382972" y="5188229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/>
          <p:cNvSpPr txBox="1"/>
          <p:nvPr/>
        </p:nvSpPr>
        <p:spPr>
          <a:xfrm>
            <a:off x="5123672" y="499214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直線コネクタ 69"/>
          <p:cNvCxnSpPr/>
          <p:nvPr/>
        </p:nvCxnSpPr>
        <p:spPr>
          <a:xfrm>
            <a:off x="7590336" y="3356992"/>
            <a:ext cx="0" cy="864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>
            <a:off x="7547345" y="3362388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>
            <a:off x="7595193" y="5176811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6754892" y="5176650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>
            <a:off x="5963126" y="5182695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/>
          <p:cNvSpPr txBox="1"/>
          <p:nvPr/>
        </p:nvSpPr>
        <p:spPr>
          <a:xfrm>
            <a:off x="5810763" y="536147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4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6547227" y="536147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itchFamily="34" charset="0"/>
                <a:cs typeface="Arial" pitchFamily="34" charset="0"/>
              </a:rPr>
              <a:t>10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7380312" y="536147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itchFamily="34" charset="0"/>
                <a:cs typeface="Arial" pitchFamily="34" charset="0"/>
              </a:rPr>
              <a:t>15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6023885" y="5661248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Age (months)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7453488" y="1701347"/>
            <a:ext cx="288032" cy="121380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7" name="直線コネクタ 86"/>
          <p:cNvCxnSpPr/>
          <p:nvPr/>
        </p:nvCxnSpPr>
        <p:spPr>
          <a:xfrm>
            <a:off x="5472740" y="2935750"/>
            <a:ext cx="25922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5465365" y="827622"/>
            <a:ext cx="7375" cy="2109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/>
          <p:cNvCxnSpPr/>
          <p:nvPr/>
        </p:nvCxnSpPr>
        <p:spPr>
          <a:xfrm>
            <a:off x="5369668" y="841381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/>
          <p:cNvCxnSpPr/>
          <p:nvPr/>
        </p:nvCxnSpPr>
        <p:spPr>
          <a:xfrm>
            <a:off x="5376492" y="1517736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/>
          <p:cNvCxnSpPr/>
          <p:nvPr/>
        </p:nvCxnSpPr>
        <p:spPr>
          <a:xfrm>
            <a:off x="5383316" y="2217344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5362500" y="3640886"/>
            <a:ext cx="95697" cy="255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5369324" y="4197043"/>
            <a:ext cx="95697" cy="255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5376148" y="4716242"/>
            <a:ext cx="95697" cy="255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/>
          <p:cNvSpPr txBox="1"/>
          <p:nvPr/>
        </p:nvSpPr>
        <p:spPr>
          <a:xfrm>
            <a:off x="4788024" y="3501008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12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4788024" y="402319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08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4788024" y="4581128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04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直線コネクタ 91"/>
          <p:cNvCxnSpPr/>
          <p:nvPr/>
        </p:nvCxnSpPr>
        <p:spPr>
          <a:xfrm>
            <a:off x="5390140" y="2935577"/>
            <a:ext cx="95697" cy="255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/>
          <p:cNvSpPr txBox="1"/>
          <p:nvPr/>
        </p:nvSpPr>
        <p:spPr>
          <a:xfrm>
            <a:off x="4973746" y="66461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60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4973746" y="136279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40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4973746" y="204641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20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130840" y="273181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7" name="直線コネクタ 96"/>
          <p:cNvCxnSpPr/>
          <p:nvPr/>
        </p:nvCxnSpPr>
        <p:spPr>
          <a:xfrm>
            <a:off x="7597504" y="1628800"/>
            <a:ext cx="0" cy="864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7554513" y="1634196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/>
          <p:nvPr/>
        </p:nvCxnSpPr>
        <p:spPr>
          <a:xfrm>
            <a:off x="6755711" y="1223172"/>
            <a:ext cx="0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>
            <a:off x="6711444" y="1206390"/>
            <a:ext cx="869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/>
          <p:cNvSpPr txBox="1"/>
          <p:nvPr/>
        </p:nvSpPr>
        <p:spPr>
          <a:xfrm rot="16200000">
            <a:off x="3740870" y="1527895"/>
            <a:ext cx="158889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600"/>
              </a:lnSpc>
            </a:pP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Soluble Tau</a:t>
            </a:r>
            <a:endParaRPr kumimoji="1" lang="en-US" altLang="ja-JP" sz="1600" b="1" dirty="0" smtClean="0"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ts val="1600"/>
              </a:lnSpc>
            </a:pP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6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/mg tissue)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2" name="直線コネクタ 101"/>
          <p:cNvCxnSpPr/>
          <p:nvPr/>
        </p:nvCxnSpPr>
        <p:spPr>
          <a:xfrm>
            <a:off x="7602361" y="2916480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>
            <a:off x="6762060" y="2916319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>
            <a:off x="5945478" y="2922364"/>
            <a:ext cx="0" cy="1187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テキスト ボックス 105"/>
          <p:cNvSpPr txBox="1"/>
          <p:nvPr/>
        </p:nvSpPr>
        <p:spPr>
          <a:xfrm>
            <a:off x="5839197" y="310114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6607067" y="1366816"/>
            <a:ext cx="288032" cy="155812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正方形/長方形 110"/>
          <p:cNvSpPr/>
          <p:nvPr/>
        </p:nvSpPr>
        <p:spPr>
          <a:xfrm>
            <a:off x="5805262" y="1704058"/>
            <a:ext cx="288032" cy="121380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2" name="直線コネクタ 111"/>
          <p:cNvCxnSpPr/>
          <p:nvPr/>
        </p:nvCxnSpPr>
        <p:spPr>
          <a:xfrm>
            <a:off x="5949278" y="1398374"/>
            <a:ext cx="0" cy="9505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/>
          <p:cNvCxnSpPr/>
          <p:nvPr/>
        </p:nvCxnSpPr>
        <p:spPr>
          <a:xfrm>
            <a:off x="5906287" y="1418015"/>
            <a:ext cx="95697" cy="344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テキスト ボックス 113"/>
          <p:cNvSpPr txBox="1"/>
          <p:nvPr/>
        </p:nvSpPr>
        <p:spPr>
          <a:xfrm rot="16200000">
            <a:off x="3740870" y="3943946"/>
            <a:ext cx="158889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600"/>
              </a:lnSpc>
            </a:pP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Insoluble Tau</a:t>
            </a:r>
            <a:endParaRPr kumimoji="1" lang="en-US" altLang="ja-JP" sz="1600" b="1" dirty="0" smtClean="0"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ts val="1600"/>
              </a:lnSpc>
            </a:pP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6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/mg tissue)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直線コネクタ 115"/>
          <p:cNvCxnSpPr/>
          <p:nvPr/>
        </p:nvCxnSpPr>
        <p:spPr>
          <a:xfrm>
            <a:off x="5361665" y="3095453"/>
            <a:ext cx="95697" cy="34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6"/>
          <p:cNvSpPr txBox="1"/>
          <p:nvPr/>
        </p:nvSpPr>
        <p:spPr>
          <a:xfrm>
            <a:off x="4788024" y="2914796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0.16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6610876" y="3640886"/>
            <a:ext cx="288032" cy="155456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9" name="直線コネクタ 118"/>
          <p:cNvCxnSpPr/>
          <p:nvPr/>
        </p:nvCxnSpPr>
        <p:spPr>
          <a:xfrm>
            <a:off x="6754892" y="3212976"/>
            <a:ext cx="0" cy="864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/>
          <p:cNvCxnSpPr/>
          <p:nvPr/>
        </p:nvCxnSpPr>
        <p:spPr>
          <a:xfrm>
            <a:off x="6711901" y="3218372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正方形/長方形 120"/>
          <p:cNvSpPr/>
          <p:nvPr/>
        </p:nvSpPr>
        <p:spPr>
          <a:xfrm>
            <a:off x="5817402" y="4279446"/>
            <a:ext cx="288032" cy="90723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2" name="直線コネクタ 121"/>
          <p:cNvCxnSpPr/>
          <p:nvPr/>
        </p:nvCxnSpPr>
        <p:spPr>
          <a:xfrm>
            <a:off x="5961418" y="3717032"/>
            <a:ext cx="0" cy="864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5918427" y="3722428"/>
            <a:ext cx="95697" cy="31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テキスト ボックス 123"/>
          <p:cNvSpPr txBox="1"/>
          <p:nvPr/>
        </p:nvSpPr>
        <p:spPr>
          <a:xfrm>
            <a:off x="5702545" y="59678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397812" y="219484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899256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50</Words>
  <Application>Microsoft Office PowerPoint</Application>
  <PresentationFormat>画面に合わせる (4:3)</PresentationFormat>
  <Paragraphs>3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 Maekawa</dc:creator>
  <cp:lastModifiedBy>Keiko Maekawa</cp:lastModifiedBy>
  <cp:revision>8</cp:revision>
  <dcterms:created xsi:type="dcterms:W3CDTF">2013-04-14T14:03:40Z</dcterms:created>
  <dcterms:modified xsi:type="dcterms:W3CDTF">2013-04-15T12:57:42Z</dcterms:modified>
</cp:coreProperties>
</file>